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91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F6A00BE-1A8B-45A3-B34A-3BD4AEC2E9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B0FD60E0-6CA8-464E-84C2-3C47F43BC4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0C8CC08E-2B6C-4F13-9681-DF2922053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B93EE4BF-EB1D-47CB-BF54-A6EE8F3D6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16DD335-B104-4DA2-896B-D2141A654D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148131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EE3FAA6B-BB65-4AD2-9DDA-EA9514573F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033BE88A-9BFC-483E-AD0F-AA7E584E45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203A87B4-32AF-4B57-AE55-F6E9E8006C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5C31B1D0-4948-4E01-8B3B-CC816BBD4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ACF99CC-AA10-4CB6-816F-00C2D5C72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42934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FC35980D-A914-4804-9999-6A51757997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88BB939B-32F9-460D-A8C0-8F64BA04DB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E76D6676-A835-446E-93FB-B35949846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ADDB9991-6DC3-45A8-9F3C-A1DB829F6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CA7A3B4-C258-4C72-9ABE-2FEFE9D92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12954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78D757F9-52A1-458B-AB2B-7234490303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485E96C5-F938-43E3-8F68-22D78A317E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42083BDD-E42C-4831-83B5-7EDE2CCC1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9AC58B12-61EC-48F0-9639-82F42ED87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51C445A1-1C54-4629-B859-CB3939D9E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807767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5DFDF534-EA79-4AEC-A2CC-C8860A7F7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D46D80B9-D3EB-4D36-A24A-600DEA4695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BC3C7464-820E-4553-BD48-F82B2F45F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C523252F-21B2-485F-B193-6AF5AB6EE5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42ABE0AA-CB9F-4B5C-9066-357795509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69821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0291DF6A-F561-4E7A-BE8A-699E6C6E93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DB61EDBF-08A2-49F0-8031-278622F6A4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53DA2256-DEB0-49E7-9A05-67D227163F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2405982B-01B6-4823-8A3C-52337402F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5676F5D1-E7C0-4A7E-97F8-16761A2D8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7C5959DC-372F-4F52-8B52-FF810CAC3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35801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B1FAAB48-C0FC-418D-A78D-D141EC3F5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126BDA4F-7C23-4621-87E3-F345248A37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58F3E17C-0D3A-4357-97F2-94483AE437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E334F473-8F7F-4E73-8213-979F4A6B1C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5CFED459-0470-4ADD-BF9C-85B60A5A7E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CD3BF534-4898-47B9-80E9-7D5A91F4D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AC0015E6-D6C0-4E2F-90A7-72CE4DED68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BCB4B9BD-579F-456A-B32B-E8E9669F1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17939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59BE49E-C3CF-445B-B85F-BA7431874A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0C06F455-482B-4AFC-B3DC-C55AA23BD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BC9A4CBB-8752-49AB-ACEE-6B0C988D7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9F2FCB85-FE24-47E8-8186-AA0D2B84A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78018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BB860D29-E04A-4C1E-9608-E24B9F654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D13ADE8A-B0F0-44FE-8F9D-79E4BA966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3B79B124-6B97-4ECE-9141-39661C206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515561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A8E2C3E6-111A-4510-939A-7E36DC0A48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4BAB1DD1-18AE-4C10-9225-8F02D266B3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4791B8A6-2FF5-45AC-B632-E07E2D1F47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0B94CE9A-52E1-4069-AA00-A153D8DE1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4DDEAAC9-A0C4-474A-AB34-3CC87F167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75BEF75B-1B38-4E11-8953-D31AD91D2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818706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7737EF3B-24F2-4C93-8E33-3B9D888CC5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F36BC07E-DB27-4CC1-A53A-C692388406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9C84EEED-431B-49AA-AA34-6BC3BB8173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DE4EFCA0-E8A4-4AEB-9E6F-BBDCB32A6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4610510F-B2BD-4A0D-BAE8-40AF5391D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C6E97FE2-6CED-4583-856A-0FBBCEAF7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48514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3964A862-5BC5-4EC4-B4C0-EED51DF796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317CB0CE-124E-4484-B911-C5C3A81E83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85BEAEE5-369D-4321-B7C4-B8F2953712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1C5FFD-0599-4481-8CB9-C0A2B4EFF754}" type="datetimeFigureOut">
              <a:rPr lang="cs-CZ" smtClean="0"/>
              <a:t>28.10.2019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1D66B64C-D320-437B-B27E-1325F0F482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C85309DD-155E-4007-889D-44F51F727B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CA6149-3D54-47F3-9AE4-5CA29D97991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670673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1_190905_32_001_FGF2-d6">
            <a:hlinkClick r:id="" action="ppaction://media"/>
            <a:extLst>
              <a:ext uri="{FF2B5EF4-FFF2-40B4-BE49-F238E27FC236}">
                <a16:creationId xmlns:a16="http://schemas.microsoft.com/office/drawing/2014/main" id="{BAD87263-9F90-4523-8503-B78753A84FE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26183" t="17269" r="25116" b="21237"/>
          <a:stretch/>
        </p:blipFill>
        <p:spPr>
          <a:xfrm>
            <a:off x="1433384" y="1954061"/>
            <a:ext cx="4426209" cy="4411519"/>
          </a:xfrm>
          <a:prstGeom prst="rect">
            <a:avLst/>
          </a:prstGeom>
        </p:spPr>
      </p:pic>
      <p:pic>
        <p:nvPicPr>
          <p:cNvPr id="5" name="1_190905_32_002_Lact_d2o">
            <a:hlinkClick r:id="" action="ppaction://media"/>
            <a:extLst>
              <a:ext uri="{FF2B5EF4-FFF2-40B4-BE49-F238E27FC236}">
                <a16:creationId xmlns:a16="http://schemas.microsoft.com/office/drawing/2014/main" id="{B6FDA552-F009-4ED4-9AE3-AFC812ABC00A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7"/>
          <a:srcRect l="28421" t="20680" r="24145" b="17270"/>
          <a:stretch/>
        </p:blipFill>
        <p:spPr>
          <a:xfrm>
            <a:off x="6332406" y="1954060"/>
            <a:ext cx="4414133" cy="4399485"/>
          </a:xfrm>
          <a:prstGeom prst="rect">
            <a:avLst/>
          </a:prstGeom>
        </p:spPr>
      </p:pic>
      <p:sp>
        <p:nvSpPr>
          <p:cNvPr id="6" name="TextovéPole 5">
            <a:extLst>
              <a:ext uri="{FF2B5EF4-FFF2-40B4-BE49-F238E27FC236}">
                <a16:creationId xmlns:a16="http://schemas.microsoft.com/office/drawing/2014/main" id="{65A796DF-0BD4-4D0C-9B31-731323E33CDE}"/>
              </a:ext>
            </a:extLst>
          </p:cNvPr>
          <p:cNvSpPr txBox="1"/>
          <p:nvPr/>
        </p:nvSpPr>
        <p:spPr>
          <a:xfrm>
            <a:off x="1445460" y="1495524"/>
            <a:ext cx="44141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2400" dirty="0"/>
              <a:t>FGF2 (</a:t>
            </a:r>
            <a:r>
              <a:rPr lang="cs-CZ" sz="2400" dirty="0" err="1"/>
              <a:t>day</a:t>
            </a:r>
            <a:r>
              <a:rPr lang="cs-CZ" sz="2400" dirty="0"/>
              <a:t> 6)</a:t>
            </a:r>
          </a:p>
        </p:txBody>
      </p:sp>
      <p:sp>
        <p:nvSpPr>
          <p:cNvPr id="7" name="TextovéPole 6">
            <a:extLst>
              <a:ext uri="{FF2B5EF4-FFF2-40B4-BE49-F238E27FC236}">
                <a16:creationId xmlns:a16="http://schemas.microsoft.com/office/drawing/2014/main" id="{D27A095C-4593-4FA8-8AD2-1FE63D87B188}"/>
              </a:ext>
            </a:extLst>
          </p:cNvPr>
          <p:cNvSpPr txBox="1"/>
          <p:nvPr/>
        </p:nvSpPr>
        <p:spPr>
          <a:xfrm>
            <a:off x="6332406" y="1495524"/>
            <a:ext cx="44262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2400" dirty="0"/>
              <a:t>FGF2-LM (</a:t>
            </a:r>
            <a:r>
              <a:rPr lang="cs-CZ" sz="2400" dirty="0" err="1"/>
              <a:t>day</a:t>
            </a:r>
            <a:r>
              <a:rPr lang="cs-CZ" sz="2400" dirty="0"/>
              <a:t> 10)</a:t>
            </a:r>
          </a:p>
        </p:txBody>
      </p:sp>
      <p:sp>
        <p:nvSpPr>
          <p:cNvPr id="8" name="TextovéPole 7">
            <a:extLst>
              <a:ext uri="{FF2B5EF4-FFF2-40B4-BE49-F238E27FC236}">
                <a16:creationId xmlns:a16="http://schemas.microsoft.com/office/drawing/2014/main" id="{5429C623-2D73-407D-BA26-F0EA1722D84C}"/>
              </a:ext>
            </a:extLst>
          </p:cNvPr>
          <p:cNvSpPr txBox="1"/>
          <p:nvPr/>
        </p:nvSpPr>
        <p:spPr>
          <a:xfrm>
            <a:off x="1946366" y="6353545"/>
            <a:ext cx="99893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cs-CZ" sz="2400" dirty="0" err="1"/>
              <a:t>Movies</a:t>
            </a:r>
            <a:r>
              <a:rPr lang="cs-CZ" sz="2400" dirty="0"/>
              <a:t> </a:t>
            </a:r>
            <a:r>
              <a:rPr lang="cs-CZ" sz="2400" dirty="0" err="1"/>
              <a:t>depicting</a:t>
            </a:r>
            <a:r>
              <a:rPr lang="cs-CZ" sz="2400" dirty="0"/>
              <a:t> </a:t>
            </a:r>
            <a:r>
              <a:rPr lang="cs-CZ" sz="2400" dirty="0" err="1"/>
              <a:t>tha</a:t>
            </a:r>
            <a:r>
              <a:rPr lang="cs-CZ" sz="2400" dirty="0"/>
              <a:t> </a:t>
            </a:r>
            <a:r>
              <a:rPr lang="cs-CZ" sz="2400" dirty="0" err="1"/>
              <a:t>same</a:t>
            </a:r>
            <a:r>
              <a:rPr lang="cs-CZ" sz="2400" dirty="0"/>
              <a:t> organoid, 2 </a:t>
            </a:r>
            <a:r>
              <a:rPr lang="cs-CZ" sz="2400" dirty="0" err="1"/>
              <a:t>minutes</a:t>
            </a:r>
            <a:r>
              <a:rPr lang="cs-CZ" sz="2400" dirty="0"/>
              <a:t> </a:t>
            </a:r>
            <a:r>
              <a:rPr lang="cs-CZ" sz="2400" dirty="0" err="1"/>
              <a:t>movie</a:t>
            </a:r>
            <a:r>
              <a:rPr lang="cs-CZ" sz="2400" dirty="0"/>
              <a:t>, </a:t>
            </a:r>
            <a:r>
              <a:rPr lang="cs-CZ" sz="2400" dirty="0" err="1"/>
              <a:t>scalebar</a:t>
            </a:r>
            <a:r>
              <a:rPr lang="cs-CZ" sz="2400" dirty="0"/>
              <a:t> = 100 </a:t>
            </a:r>
            <a:r>
              <a:rPr lang="el-GR" sz="2400" dirty="0"/>
              <a:t>μ</a:t>
            </a:r>
            <a:r>
              <a:rPr lang="cs-CZ" sz="2400" dirty="0"/>
              <a:t>m</a:t>
            </a:r>
          </a:p>
        </p:txBody>
      </p:sp>
      <p:cxnSp>
        <p:nvCxnSpPr>
          <p:cNvPr id="9" name="Přímá spojnice 8">
            <a:extLst>
              <a:ext uri="{FF2B5EF4-FFF2-40B4-BE49-F238E27FC236}">
                <a16:creationId xmlns:a16="http://schemas.microsoft.com/office/drawing/2014/main" id="{B6BFCDC3-94EC-443B-B44B-E5325DC7E79D}"/>
              </a:ext>
            </a:extLst>
          </p:cNvPr>
          <p:cNvCxnSpPr>
            <a:cxnSpLocks/>
          </p:cNvCxnSpPr>
          <p:nvPr/>
        </p:nvCxnSpPr>
        <p:spPr>
          <a:xfrm>
            <a:off x="4652477" y="6189665"/>
            <a:ext cx="1080000" cy="0"/>
          </a:xfrm>
          <a:prstGeom prst="line">
            <a:avLst/>
          </a:prstGeom>
          <a:ln w="76200">
            <a:solidFill>
              <a:srgbClr val="00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Přímá spojnice 9">
            <a:extLst>
              <a:ext uri="{FF2B5EF4-FFF2-40B4-BE49-F238E27FC236}">
                <a16:creationId xmlns:a16="http://schemas.microsoft.com/office/drawing/2014/main" id="{EC1A71CF-F969-475B-9F9F-E9E8C81D0302}"/>
              </a:ext>
            </a:extLst>
          </p:cNvPr>
          <p:cNvCxnSpPr>
            <a:cxnSpLocks/>
          </p:cNvCxnSpPr>
          <p:nvPr/>
        </p:nvCxnSpPr>
        <p:spPr>
          <a:xfrm>
            <a:off x="9527237" y="6188080"/>
            <a:ext cx="1080000" cy="0"/>
          </a:xfrm>
          <a:prstGeom prst="line">
            <a:avLst/>
          </a:prstGeom>
          <a:ln w="76200">
            <a:solidFill>
              <a:srgbClr val="00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" name="TextovéPole 10">
            <a:extLst>
              <a:ext uri="{FF2B5EF4-FFF2-40B4-BE49-F238E27FC236}">
                <a16:creationId xmlns:a16="http://schemas.microsoft.com/office/drawing/2014/main" id="{98B4FD4E-13BA-4BA3-A54A-21589212E9F4}"/>
              </a:ext>
            </a:extLst>
          </p:cNvPr>
          <p:cNvSpPr txBox="1"/>
          <p:nvPr/>
        </p:nvSpPr>
        <p:spPr>
          <a:xfrm>
            <a:off x="1441104" y="942528"/>
            <a:ext cx="44141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2400" b="1" dirty="0" err="1"/>
              <a:t>Movie</a:t>
            </a:r>
            <a:r>
              <a:rPr lang="cs-CZ" sz="2400" b="1" dirty="0"/>
              <a:t> 1</a:t>
            </a:r>
          </a:p>
        </p:txBody>
      </p:sp>
      <p:sp>
        <p:nvSpPr>
          <p:cNvPr id="12" name="TextovéPole 11">
            <a:extLst>
              <a:ext uri="{FF2B5EF4-FFF2-40B4-BE49-F238E27FC236}">
                <a16:creationId xmlns:a16="http://schemas.microsoft.com/office/drawing/2014/main" id="{2CC034E6-5500-4E92-9C01-0C39E46A624B}"/>
              </a:ext>
            </a:extLst>
          </p:cNvPr>
          <p:cNvSpPr txBox="1"/>
          <p:nvPr/>
        </p:nvSpPr>
        <p:spPr>
          <a:xfrm>
            <a:off x="6332406" y="942528"/>
            <a:ext cx="44262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2400" b="1" dirty="0" err="1"/>
              <a:t>Movie</a:t>
            </a:r>
            <a:r>
              <a:rPr lang="cs-CZ" sz="2400" b="1" dirty="0"/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37829612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20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20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9</Words>
  <Application>Microsoft Office PowerPoint</Application>
  <PresentationFormat>Širokoúhlá obrazovka</PresentationFormat>
  <Paragraphs>5</Paragraphs>
  <Slides>1</Slides>
  <Notes>0</Notes>
  <HiddenSlides>0</HiddenSlides>
  <MMClips>2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Jakub Sumbal</dc:creator>
  <cp:lastModifiedBy>Jakub Sumbal</cp:lastModifiedBy>
  <cp:revision>3</cp:revision>
  <dcterms:created xsi:type="dcterms:W3CDTF">2019-09-26T08:16:41Z</dcterms:created>
  <dcterms:modified xsi:type="dcterms:W3CDTF">2019-10-28T13:34:06Z</dcterms:modified>
</cp:coreProperties>
</file>